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948488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48000" cy="927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09960" cy="46368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35160" y="0"/>
            <a:ext cx="3009960" cy="46368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69720" y="695160"/>
            <a:ext cx="2608200" cy="3476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5160" y="4403880"/>
            <a:ext cx="5556240" cy="417168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05600"/>
            <a:ext cx="3009960" cy="4633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35160" y="8805600"/>
            <a:ext cx="3009960" cy="4633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fld id="{8FDA0948-11FE-427B-8D2A-D65CCFC0C5E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Rectangle 7"/>
          <p:cNvSpPr/>
          <p:nvPr/>
        </p:nvSpPr>
        <p:spPr>
          <a:xfrm>
            <a:off x="3935520" y="8805960"/>
            <a:ext cx="300996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440" bIns="46440" anchor="b">
            <a:noAutofit/>
          </a:bodyPr>
          <a:p>
            <a:pPr algn="r"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fld id="{AF21FD53-4690-4548-AAEF-9B00E24184E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2170080" y="695160"/>
            <a:ext cx="2608200" cy="347688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93360" y="4403880"/>
            <a:ext cx="5559480" cy="417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CA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4F03D-B409-45A3-AB9C-CAD01D7C42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65E01-9EC7-4015-95FC-27FD3FA536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867B8-EDAE-41EE-8C8F-8F40C98065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9D1AF-C602-48E4-A1D5-EE3631C587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0ECD2-A7CC-4D23-882A-BE7F7A241E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A3D7A-DC37-4394-9A10-2B8A83E31B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9EEF9-1BE4-4ECF-B24E-B448E6009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87B2F-F793-45E5-8AFF-1A2B2BCCD3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9131D-362C-4EFB-8414-1BB5222F50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DFB0C-FD00-4CB3-AED2-C267195BB3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E4ACF-E260-46B4-8049-129073FE0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BCD38-8EC0-41E9-AE3E-43916CF3BC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EBAD42-2C50-476B-B16D-DAF9F0BCE5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79" descr=""/>
          <p:cNvPicPr/>
          <p:nvPr/>
        </p:nvPicPr>
        <p:blipFill>
          <a:blip r:embed="rId1"/>
          <a:stretch/>
        </p:blipFill>
        <p:spPr>
          <a:xfrm>
            <a:off x="1131840" y="1876320"/>
            <a:ext cx="4721400" cy="10954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80" descr=""/>
          <p:cNvPicPr/>
          <p:nvPr/>
        </p:nvPicPr>
        <p:blipFill>
          <a:blip r:embed="rId2"/>
          <a:stretch/>
        </p:blipFill>
        <p:spPr>
          <a:xfrm>
            <a:off x="1219320" y="4408560"/>
            <a:ext cx="4724280" cy="1133280"/>
          </a:xfrm>
          <a:prstGeom prst="rect">
            <a:avLst/>
          </a:prstGeom>
          <a:ln w="0">
            <a:noFill/>
          </a:ln>
        </p:spPr>
      </p:pic>
      <p:sp>
        <p:nvSpPr>
          <p:cNvPr id="50" name="Text Box 46"/>
          <p:cNvSpPr/>
          <p:nvPr/>
        </p:nvSpPr>
        <p:spPr>
          <a:xfrm>
            <a:off x="146520" y="3809880"/>
            <a:ext cx="57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B230850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   -   +   +     -    -     +   +     -   -    +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"/>
          <p:cNvSpPr/>
          <p:nvPr/>
        </p:nvSpPr>
        <p:spPr>
          <a:xfrm>
            <a:off x="339480" y="4017960"/>
            <a:ext cx="5540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JSI-124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  +   -    +     -    +     -   +     -   +   - 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1526400" y="5541840"/>
            <a:ext cx="409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JAB                 I-83                NALM-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6"/>
          <p:cNvSpPr/>
          <p:nvPr/>
        </p:nvSpPr>
        <p:spPr>
          <a:xfrm>
            <a:off x="56880" y="1295280"/>
            <a:ext cx="5751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0126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   -   +   +     -    -     +   +     -   -    +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11"/>
          <p:cNvSpPr/>
          <p:nvPr/>
        </p:nvSpPr>
        <p:spPr>
          <a:xfrm>
            <a:off x="250560" y="1503360"/>
            <a:ext cx="5540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JSI-124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  +   -    +     -    +     -   +     -   +   - 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12"/>
          <p:cNvSpPr/>
          <p:nvPr/>
        </p:nvSpPr>
        <p:spPr>
          <a:xfrm>
            <a:off x="1439280" y="2982960"/>
            <a:ext cx="409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JAB                 I-83                NALM-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03"/>
          <p:cNvSpPr/>
          <p:nvPr/>
        </p:nvSpPr>
        <p:spPr>
          <a:xfrm>
            <a:off x="5793480" y="2438280"/>
            <a:ext cx="86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03"/>
          <p:cNvSpPr/>
          <p:nvPr/>
        </p:nvSpPr>
        <p:spPr>
          <a:xfrm>
            <a:off x="5909400" y="5129280"/>
            <a:ext cx="86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"/>
          <p:cNvSpPr/>
          <p:nvPr/>
        </p:nvSpPr>
        <p:spPr>
          <a:xfrm>
            <a:off x="5810760" y="182880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-Ju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8"/>
          <p:cNvSpPr/>
          <p:nvPr/>
        </p:nvSpPr>
        <p:spPr>
          <a:xfrm>
            <a:off x="5972760" y="447516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-Ju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Object 4"/>
          <p:cNvGraphicFramePr/>
          <p:nvPr/>
        </p:nvGraphicFramePr>
        <p:xfrm>
          <a:off x="1482840" y="7010280"/>
          <a:ext cx="4190760" cy="480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1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482840" y="7010280"/>
                    <a:ext cx="4190760" cy="480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2" name="Text Box 46"/>
          <p:cNvSpPr/>
          <p:nvPr/>
        </p:nvSpPr>
        <p:spPr>
          <a:xfrm>
            <a:off x="687960" y="6324480"/>
            <a:ext cx="4877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G132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-   + +     -    -   +  +     -   -   +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5"/>
          <p:cNvSpPr/>
          <p:nvPr/>
        </p:nvSpPr>
        <p:spPr>
          <a:xfrm>
            <a:off x="669600" y="6532560"/>
            <a:ext cx="4909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JSI-124    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   +  -  +      -   +   -  +     -   +  -  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6"/>
          <p:cNvSpPr/>
          <p:nvPr/>
        </p:nvSpPr>
        <p:spPr>
          <a:xfrm>
            <a:off x="1477080" y="7924680"/>
            <a:ext cx="409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JAB                 I-83                NALM-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03"/>
          <p:cNvSpPr/>
          <p:nvPr/>
        </p:nvSpPr>
        <p:spPr>
          <a:xfrm>
            <a:off x="5752440" y="7543800"/>
            <a:ext cx="86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8"/>
          <p:cNvSpPr/>
          <p:nvPr/>
        </p:nvSpPr>
        <p:spPr>
          <a:xfrm>
            <a:off x="5752080" y="70102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-Ju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Object 22"/>
          <p:cNvGraphicFramePr/>
          <p:nvPr/>
        </p:nvGraphicFramePr>
        <p:xfrm>
          <a:off x="1482840" y="7543800"/>
          <a:ext cx="4190760" cy="4208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8" name="Object 2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482840" y="7543800"/>
                    <a:ext cx="4190760" cy="42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9" name="TextBox 1"/>
          <p:cNvSpPr/>
          <p:nvPr/>
        </p:nvSpPr>
        <p:spPr>
          <a:xfrm>
            <a:off x="165600" y="609480"/>
            <a:ext cx="43668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i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ii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6T21:34:32Z</dcterms:created>
  <dc:creator>family</dc:creator>
  <dc:description/>
  <dc:language>en-US</dc:language>
  <cp:lastModifiedBy>Owner</cp:lastModifiedBy>
  <dcterms:modified xsi:type="dcterms:W3CDTF">2011-06-16T14:36:02Z</dcterms:modified>
  <cp:revision>165</cp:revision>
  <dc:subject/>
  <dc:title>Slide 1</dc:title>
</cp:coreProperties>
</file>